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149ED7-3161-491B-958D-153D3F11E56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E67E23-FC10-436D-91B0-F316E8035C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207C13-870F-48F6-8EA8-7ED572CAD02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DFBF1B-20BB-4C47-AF28-2C77D70C257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1ABD7A-AED2-4CA8-9155-270EE3A0C9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9500C5-797D-4FF7-9B83-4E9093C618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C7C663-D2FE-4655-B73C-6FF2803583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FEC662-4E29-4838-AE81-6A597ED564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5E730C-166F-4540-BD5D-C056D3DFB1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AC4D35-229F-40FC-97D4-7BED28A58E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662729-B1A1-4153-8FAB-5580B91E48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C56984-5CF5-412D-BE76-0AB1F10762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DDCEC64-287C-4E1F-8E44-A24624ACAF6B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701640"/>
            <a:ext cx="4740120" cy="313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                66        28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     ACGCAG    gtgag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              298         3.1           ttccag    TCAGTT              GGCACG    gtaaga    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              119         0.6           tcatag    AACGAG             AGGTGT     gtttg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              123         0.1           ttccag    CCCAGG             TACCAG     gtggg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                90         2              cttcag    CCAAAT              AGCATG     gtaat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                78         0.2           cttcag    AACGAG             ATCCCA     gtgcca 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              102         1.3           tcccag   GTGAAA              TTCCAG     gtaaaa 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              182         3.6          gcacag   AGAAAT              CAAGAG     gtgag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                97         0.1          tcaaag    GGCCGC            ACACAG     gtaagg 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            129         2               tttcag    TCTGCA             CTCAAA     gtacg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1            105         3.2            tttcag    GTCATG             TTCAAG     gtgag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2              92         1.4          atacag    CAACTC             ATCTCG     gtagg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3            118         4.2         gcacag    GGACGT            AGCGAG    gtgcg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4            123         1.8          gtgcag    GAGGTC            TAGGAA     gtggt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            126         7.1          ccacag   TTCCTG            GTGGAG      gtgag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6            167         0.7          ccgcag    GATCGC            CCGGAG    gtcag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7            148         1.2           gttcag    TCCTGC             ACTCAG     gttct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4572000" y="701640"/>
            <a:ext cx="4527720" cy="253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8        154        1.5           gataat      CTTTAC          TCAGTG       gtaag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9        157        2.4           ttcgag      TGTGGG         TGCTCT       gtcac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          97        1.3          ctgcag       GTACGT        GCCGAG       gtgag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1          77        0.1           cttcag       GTGAAT        AGGAAG        gtgag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        109        1.2          cactag       TTTGCT         GTGCAG       gtgag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3        120        5.3         cgccag       CTCCTC          ATAGTT       gtaag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4        200       10           ccacag       GAGCTG         CAACCG      gtgag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5          88       9.8            gtttag        ATTTTA         ACCAAG       gtagg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6        144       0.9           ttccag        GCTTTG         AGCCTG       gtgag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7          91       1.7          cggcag       CTGCAA         CTCCTG       gtgag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8        131       4.6           ccgtag       GTATCC         AGCCTG       gtgag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9          73       0.5            ctctag       TCTTTA          TGAAAG       gtgag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          95       0.8           ctgcag       GGGAGA        CCTCGA       gtaac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1        239       1.3           ctgcag       CAAATT         AGTCGA       gtaag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2        148       2.6            tcctag       AGTGCT        AATGTG        gtatgt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3         2.6                         ttgtag       TATCCT         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0" y="295200"/>
            <a:ext cx="4284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xon      Exon     Intron        Intron       Exon                     Exon    Intro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             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p         kb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4495680" y="311040"/>
            <a:ext cx="4284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xon   Exon     Intron         Intron          Exon                Exon        Intro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         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p           kb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44280" y="3352680"/>
            <a:ext cx="8871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44280" y="701640"/>
            <a:ext cx="8871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60480" y="320760"/>
            <a:ext cx="8870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-302040" y="4665600"/>
            <a:ext cx="5293800" cy="146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           286         2.7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                          ACTAGG          gtgag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           136         5.3            ttctag      GCTGGA         CAAGCT          gtaag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           122         1.6           ttgcag      GCTCTC          CAAACT          gtaag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             99         4.5          gcccag     GCTGGA          TACAGG         tatgt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           232         1.3            gtttag      GTTTGA          TTACAT          gtaag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             57         5.2          tcacag      GTCCAG          TGTCAA         gtatg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             91            2           tctaag      TGGGAG          AGTAAG        gtaag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           161         5.4            tttcag       TGCCAT         TTCCAG         gtaag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         1503                        ctccag       GTTTTG          TGCATT    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144360" y="4184640"/>
            <a:ext cx="45957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xon     Exon      Intron     Intron            Exon             Exon              Intro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            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p        kb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 flipV="1">
            <a:off x="144360" y="4129200"/>
            <a:ext cx="43149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 flipV="1">
            <a:off x="160200" y="4584240"/>
            <a:ext cx="43149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 flipV="1">
            <a:off x="176040" y="6133680"/>
            <a:ext cx="43149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66240" y="41400"/>
            <a:ext cx="354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able S2A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ntron-exon structure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YFIP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gene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36000" y="3760920"/>
            <a:ext cx="3498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able S2B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ntron-exon structure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NIPA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gene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3-01-30T03:17:42Z</dcterms:created>
  <dc:creator>Yong hui Jiang</dc:creator>
  <dc:description/>
  <dc:language>en-US</dc:language>
  <cp:lastModifiedBy>yjiang</cp:lastModifiedBy>
  <dcterms:modified xsi:type="dcterms:W3CDTF">2007-11-21T22:57:15Z</dcterms:modified>
  <cp:revision>38</cp:revision>
  <dc:subject/>
  <dc:title>PowerPoint Presentation</dc:title>
</cp:coreProperties>
</file>